
<file path=[Content_Types].xml><?xml version="1.0" encoding="utf-8"?>
<Types xmlns="http://schemas.openxmlformats.org/package/2006/content-types">
  <Default Extension="png" ContentType="image/png"/>
  <Default Extension="tmp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63" d="100"/>
          <a:sy n="63" d="100"/>
        </p:scale>
        <p:origin x="696" y="6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553BD9E-EC56-46BC-A935-FEE67433913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2718EAF5-8E35-4B18-BD82-32949CE6CBB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BA44E23-01B2-4116-A0A3-E4E586A527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D7316-3D4F-45DB-BCE3-EC113C558375}" type="datetimeFigureOut">
              <a:rPr lang="en-US" smtClean="0"/>
              <a:t>11/28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2504348-E300-4E5E-8929-84E9334C83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4FA7263-7A5F-4EA5-B139-38D0FB7689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664DA-7BDA-4D90-9FC2-D7D438D8DEE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44772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6939B6A-10DA-4EB6-A374-8A6F54DB90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21CFD7A3-9988-49C2-A47C-CB5D661EFB7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28997A5-850B-4BF8-9AB3-10EA719694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D7316-3D4F-45DB-BCE3-EC113C558375}" type="datetimeFigureOut">
              <a:rPr lang="en-US" smtClean="0"/>
              <a:t>11/28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E78797F-8A3A-4C61-B7C6-6103761934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7871060-1E4C-4479-836C-7067BBDBC9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664DA-7BDA-4D90-9FC2-D7D438D8DEE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5880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5F720570-8AC6-4928-9A10-6765DF7B18B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01779C5B-DDAA-499E-9BE0-08F8363A34F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4C05827-EB47-40B6-9D28-931BF6A53E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D7316-3D4F-45DB-BCE3-EC113C558375}" type="datetimeFigureOut">
              <a:rPr lang="en-US" smtClean="0"/>
              <a:t>11/28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6736637-DEAF-4575-BED3-8A58FCB17B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C0756E4-D44B-45CC-A803-A8177D443D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664DA-7BDA-4D90-9FC2-D7D438D8DEE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81869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B6D609A-89EC-44E7-B482-942D048063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531A51B7-A100-4CF2-908E-9E62DDAF8E1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9F6D9C2-6FF5-4F1D-A96B-EFA405AE82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D7316-3D4F-45DB-BCE3-EC113C558375}" type="datetimeFigureOut">
              <a:rPr lang="en-US" smtClean="0"/>
              <a:t>11/28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3C4B003-33A9-42FC-A544-4429240DBF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96B7660-7082-432A-AE16-7988E889CF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664DA-7BDA-4D90-9FC2-D7D438D8DEE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4562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C84FE18-C074-458B-A50D-00C3ECE5BD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34AF0D6B-DC63-48AC-9C0F-E5D0F07AA3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115C3B3-C77F-4F66-A3F3-A5EFD77600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D7316-3D4F-45DB-BCE3-EC113C558375}" type="datetimeFigureOut">
              <a:rPr lang="en-US" smtClean="0"/>
              <a:t>11/28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6C7E6C4-C7C5-4E6F-9BAB-AA6C9CC08E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3366C5B-8C92-4BF1-A233-8D8D53EF28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664DA-7BDA-4D90-9FC2-D7D438D8DEE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22167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8411E20-9F37-4F70-ADE6-7DC061169A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82C94084-7CA4-40AA-98FC-1A2FAE19C6F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2AF50FC0-967B-4038-89E5-006DDFE086D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DBCD848E-3684-44A6-A7F2-93F49F53BD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D7316-3D4F-45DB-BCE3-EC113C558375}" type="datetimeFigureOut">
              <a:rPr lang="en-US" smtClean="0"/>
              <a:t>11/28/2024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431E780C-810F-43D6-ADEB-1C93AE17EB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827EC6F3-E0CF-4074-9090-B7796A3F87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664DA-7BDA-4D90-9FC2-D7D438D8DEE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1115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3029F6F-5FB1-4842-97F5-EB5FDA011D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3B112A85-AFC9-4DFC-9DB3-3ECBE2FD15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69700A43-6232-4DE8-BAEB-0E6F3B3F069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294C1B27-C7AC-458D-8CF1-023A7476933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B4264597-9D08-40EF-8131-46A94A6AEC6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197601F2-705F-44C3-A6EE-30BD92E296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D7316-3D4F-45DB-BCE3-EC113C558375}" type="datetimeFigureOut">
              <a:rPr lang="en-US" smtClean="0"/>
              <a:t>11/28/2024</a:t>
            </a:fld>
            <a:endParaRPr lang="en-US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ADD6FAE7-1CCA-4452-B362-DF696FF2D5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FB191F18-F5F7-45FE-B191-4177FD2D04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664DA-7BDA-4D90-9FC2-D7D438D8DEE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0410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3353876-5DE1-4193-836A-15A6A2B172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D725C059-9F7C-45E9-9B64-8C5166FA64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D7316-3D4F-45DB-BCE3-EC113C558375}" type="datetimeFigureOut">
              <a:rPr lang="en-US" smtClean="0"/>
              <a:t>11/28/2024</a:t>
            </a:fld>
            <a:endParaRPr lang="en-US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AC26001B-FA5F-4E5F-8FEB-9170707D28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121D775A-0007-4F7A-9FFB-A2839F0F40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664DA-7BDA-4D90-9FC2-D7D438D8DEE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01769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0BACF219-ADBD-4654-A649-BF74566A11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D7316-3D4F-45DB-BCE3-EC113C558375}" type="datetimeFigureOut">
              <a:rPr lang="en-US" smtClean="0"/>
              <a:t>11/28/2024</a:t>
            </a:fld>
            <a:endParaRPr lang="en-US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B555B2D2-EBDF-466E-B26C-42DC939659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67C3C27B-AABA-4628-A5B2-776EE5901E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664DA-7BDA-4D90-9FC2-D7D438D8DEE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41598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9BD6DBD-036A-4FCF-A9CD-65C02EF6DD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8D2B707-6C39-4B18-8973-B208F752C53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CE1E87D9-0AC0-4045-9E0E-C6B500BD984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157DF84C-4196-45F2-9DB7-D8129B9248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D7316-3D4F-45DB-BCE3-EC113C558375}" type="datetimeFigureOut">
              <a:rPr lang="en-US" smtClean="0"/>
              <a:t>11/28/2024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EA032C9C-AE4D-4409-BBB7-A1E441B6A9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FADCE944-9DC3-4603-BB84-AC98E3536A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664DA-7BDA-4D90-9FC2-D7D438D8DEE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09925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DE775A9-F463-43A8-BD43-8A91DC46F2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15402BD2-F8AB-432D-BA4A-A89FE6BC9A7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45313290-8B13-4406-8886-D6E863B80B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24F5D923-9EF8-4ED1-987F-D97880C6BB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D7316-3D4F-45DB-BCE3-EC113C558375}" type="datetimeFigureOut">
              <a:rPr lang="en-US" smtClean="0"/>
              <a:t>11/28/2024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B8790A6C-A2E1-4AD8-BA8D-2160117445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E545902B-E62A-4463-9C31-6523EF80FC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664DA-7BDA-4D90-9FC2-D7D438D8DEE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59982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A22E062E-0485-49A2-9FD2-39A5628937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4897B2D4-1DFE-4CBF-8DAA-1EA5F196CF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2BBD780-7B79-4D86-ADCB-56A0A792670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1D7316-3D4F-45DB-BCE3-EC113C558375}" type="datetimeFigureOut">
              <a:rPr lang="en-US" smtClean="0"/>
              <a:t>11/28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A0766ED-B48C-4C61-AB44-22CB993C008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CF9AF28-3225-445B-8F61-BC98AB809BA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6664DA-7BDA-4D90-9FC2-D7D438D8DEE7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38640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mp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asellaDiTesto 7">
            <a:extLst>
              <a:ext uri="{FF2B5EF4-FFF2-40B4-BE49-F238E27FC236}">
                <a16:creationId xmlns:a16="http://schemas.microsoft.com/office/drawing/2014/main" id="{A0522FED-D4AE-4784-A660-42E0A6B3A199}"/>
              </a:ext>
            </a:extLst>
          </p:cNvPr>
          <p:cNvSpPr txBox="1"/>
          <p:nvPr/>
        </p:nvSpPr>
        <p:spPr>
          <a:xfrm>
            <a:off x="531223" y="1026456"/>
            <a:ext cx="1480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pic>
        <p:nvPicPr>
          <p:cNvPr id="18" name="Immagine 17">
            <a:extLst>
              <a:ext uri="{FF2B5EF4-FFF2-40B4-BE49-F238E27FC236}">
                <a16:creationId xmlns:a16="http://schemas.microsoft.com/office/drawing/2014/main" id="{BF5765CC-4C7B-4A55-AEF8-21A3432FAFE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07" r="-1"/>
          <a:stretch/>
        </p:blipFill>
        <p:spPr>
          <a:xfrm>
            <a:off x="1297058" y="1139612"/>
            <a:ext cx="9597884" cy="5343800"/>
          </a:xfrm>
          <a:prstGeom prst="rect">
            <a:avLst/>
          </a:prstGeom>
        </p:spPr>
      </p:pic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26F1A788-5DA4-46FF-A258-1CF96CA4B3CF}"/>
              </a:ext>
            </a:extLst>
          </p:cNvPr>
          <p:cNvSpPr txBox="1"/>
          <p:nvPr/>
        </p:nvSpPr>
        <p:spPr>
          <a:xfrm>
            <a:off x="357051" y="261257"/>
            <a:ext cx="1148532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Supplementary material 2: α-and β-Diversity according to sample type and antimicrobial use. A) Shannon’s and B) Simpson’s indexes. Boxplots represent 25th to 75th percentiles. β-Diversity according to Bray-Curtis distances  represented using C) NDMS and D) </a:t>
            </a:r>
            <a:r>
              <a:rPr lang="en-US" sz="1600" dirty="0" err="1"/>
              <a:t>PCoA</a:t>
            </a:r>
            <a:r>
              <a:rPr lang="en-US" sz="1600" dirty="0"/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10889873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asellaDiTesto 7">
            <a:extLst>
              <a:ext uri="{FF2B5EF4-FFF2-40B4-BE49-F238E27FC236}">
                <a16:creationId xmlns:a16="http://schemas.microsoft.com/office/drawing/2014/main" id="{A0522FED-D4AE-4784-A660-42E0A6B3A199}"/>
              </a:ext>
            </a:extLst>
          </p:cNvPr>
          <p:cNvSpPr txBox="1"/>
          <p:nvPr/>
        </p:nvSpPr>
        <p:spPr>
          <a:xfrm>
            <a:off x="531223" y="1026456"/>
            <a:ext cx="1480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  <p:pic>
        <p:nvPicPr>
          <p:cNvPr id="19" name="Immagine 18">
            <a:extLst>
              <a:ext uri="{FF2B5EF4-FFF2-40B4-BE49-F238E27FC236}">
                <a16:creationId xmlns:a16="http://schemas.microsoft.com/office/drawing/2014/main" id="{52BCF1D1-B373-4250-8874-7A0FA50FB22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97058" y="1153028"/>
            <a:ext cx="9597884" cy="51412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063419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asellaDiTesto 7">
            <a:extLst>
              <a:ext uri="{FF2B5EF4-FFF2-40B4-BE49-F238E27FC236}">
                <a16:creationId xmlns:a16="http://schemas.microsoft.com/office/drawing/2014/main" id="{A0522FED-D4AE-4784-A660-42E0A6B3A199}"/>
              </a:ext>
            </a:extLst>
          </p:cNvPr>
          <p:cNvSpPr txBox="1"/>
          <p:nvPr/>
        </p:nvSpPr>
        <p:spPr>
          <a:xfrm>
            <a:off x="531223" y="1026456"/>
            <a:ext cx="1480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</a:t>
            </a:r>
          </a:p>
        </p:txBody>
      </p:sp>
      <p:pic>
        <p:nvPicPr>
          <p:cNvPr id="22" name="Immagine 21" descr="beta_diver_permanova_NMDS_bray_curtis_treatments.pdf - Adobe Acrobat Reader DC">
            <a:extLst>
              <a:ext uri="{FF2B5EF4-FFF2-40B4-BE49-F238E27FC236}">
                <a16:creationId xmlns:a16="http://schemas.microsoft.com/office/drawing/2014/main" id="{B854FC31-DD65-4E8B-BCBC-8FCCE73032A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71" t="20001" r="32214"/>
          <a:stretch/>
        </p:blipFill>
        <p:spPr>
          <a:xfrm>
            <a:off x="2086965" y="1108286"/>
            <a:ext cx="8038389" cy="56642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1113808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asellaDiTesto 7">
            <a:extLst>
              <a:ext uri="{FF2B5EF4-FFF2-40B4-BE49-F238E27FC236}">
                <a16:creationId xmlns:a16="http://schemas.microsoft.com/office/drawing/2014/main" id="{A0522FED-D4AE-4784-A660-42E0A6B3A199}"/>
              </a:ext>
            </a:extLst>
          </p:cNvPr>
          <p:cNvSpPr txBox="1"/>
          <p:nvPr/>
        </p:nvSpPr>
        <p:spPr>
          <a:xfrm>
            <a:off x="531223" y="1026456"/>
            <a:ext cx="1480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</a:t>
            </a:r>
          </a:p>
        </p:txBody>
      </p:sp>
      <p:pic>
        <p:nvPicPr>
          <p:cNvPr id="20" name="Immagine 19">
            <a:extLst>
              <a:ext uri="{FF2B5EF4-FFF2-40B4-BE49-F238E27FC236}">
                <a16:creationId xmlns:a16="http://schemas.microsoft.com/office/drawing/2014/main" id="{6E0A32AA-ACB8-4CE5-A256-61B85411ECC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09563" y="1066980"/>
            <a:ext cx="8172872" cy="56651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6562165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49</Words>
  <Application>Microsoft Office PowerPoint</Application>
  <PresentationFormat>Widescreen</PresentationFormat>
  <Paragraphs>5</Paragraphs>
  <Slides>4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ndrea Laconi</dc:creator>
  <cp:lastModifiedBy>Andrea Laconi</cp:lastModifiedBy>
  <cp:revision>6</cp:revision>
  <dcterms:created xsi:type="dcterms:W3CDTF">2024-02-22T15:09:20Z</dcterms:created>
  <dcterms:modified xsi:type="dcterms:W3CDTF">2024-11-28T11:15:32Z</dcterms:modified>
</cp:coreProperties>
</file>